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46875" cy="98821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F2EEFB-7D96-44B0-8761-F191ACA849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9CAD0-4238-4543-A5AC-5191589844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B4D53-57E2-4C3C-A93E-FB8A436A32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F3799-E6F2-4CB9-8B7F-55FEEF049A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C3664-DF91-42B0-B4D7-011D7D3233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75DC0D-B10D-4E67-A56C-E33A2FC710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555BDE-C0EE-4D3A-ACAE-509B7381B9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23E8B-3A10-4ACC-B21C-8655A6EB8D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8A4B03-C6CE-4411-B853-0B1657F5F1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4D3F0-6E24-471B-BDE8-F31FA5CEC7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0BF737-01E4-4FA4-8128-D03410577E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C1C246-659F-43F6-8875-68B7452EF4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55AC17-AF92-4470-86EF-3CBB28C3D4E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003320" y="1282680"/>
          <a:ext cx="4599000" cy="25430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003320" y="1282680"/>
                    <a:ext cx="4599000" cy="2543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628920" y="13320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3"/>
          <a:stretch/>
        </p:blipFill>
        <p:spPr>
          <a:xfrm>
            <a:off x="981000" y="3800520"/>
            <a:ext cx="4780080" cy="268920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694080" y="39546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064600" y="702000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851920" y="3564000"/>
            <a:ext cx="115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pecies cod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0800000">
            <a:off x="836280" y="1761120"/>
            <a:ext cx="362880" cy="129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# domain copi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1697040" y="1619280"/>
            <a:ext cx="1872720" cy="573840"/>
            <a:chOff x="1697040" y="1619280"/>
            <a:chExt cx="1872720" cy="573840"/>
          </a:xfrm>
        </p:grpSpPr>
        <p:grpSp>
          <p:nvGrpSpPr>
            <p:cNvPr id="50" name=""/>
            <p:cNvGrpSpPr/>
            <p:nvPr/>
          </p:nvGrpSpPr>
          <p:grpSpPr>
            <a:xfrm>
              <a:off x="1697040" y="1693440"/>
              <a:ext cx="314640" cy="69480"/>
              <a:chOff x="1697040" y="1693440"/>
              <a:chExt cx="314640" cy="69480"/>
            </a:xfrm>
          </p:grpSpPr>
          <p:sp>
            <p:nvSpPr>
              <p:cNvPr id="51" name=""/>
              <p:cNvSpPr/>
              <p:nvPr/>
            </p:nvSpPr>
            <p:spPr>
              <a:xfrm>
                <a:off x="1697040" y="1730520"/>
                <a:ext cx="314640" cy="0"/>
              </a:xfrm>
              <a:prstGeom prst="line">
                <a:avLst/>
              </a:prstGeom>
              <a:ln w="19080">
                <a:solidFill>
                  <a:srgbClr val="3333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V="1">
                <a:off x="1788120" y="1693080"/>
                <a:ext cx="100440" cy="69480"/>
              </a:xfrm>
              <a:prstGeom prst="diamond">
                <a:avLst/>
              </a:prstGeom>
              <a:solidFill>
                <a:srgbClr val="333399"/>
              </a:solidFill>
              <a:ln w="9360">
                <a:solidFill>
                  <a:srgbClr val="3333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1880" bIns="-118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" name=""/>
            <p:cNvGrpSpPr/>
            <p:nvPr/>
          </p:nvGrpSpPr>
          <p:grpSpPr>
            <a:xfrm>
              <a:off x="1697040" y="1863000"/>
              <a:ext cx="314640" cy="69480"/>
              <a:chOff x="1697040" y="1863000"/>
              <a:chExt cx="314640" cy="69480"/>
            </a:xfrm>
          </p:grpSpPr>
          <p:sp>
            <p:nvSpPr>
              <p:cNvPr id="54" name=""/>
              <p:cNvSpPr/>
              <p:nvPr/>
            </p:nvSpPr>
            <p:spPr>
              <a:xfrm>
                <a:off x="1697040" y="1893240"/>
                <a:ext cx="314640" cy="0"/>
              </a:xfrm>
              <a:prstGeom prst="line">
                <a:avLst/>
              </a:prstGeom>
              <a:ln w="19080">
                <a:solidFill>
                  <a:srgbClr val="ff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flipV="1">
                <a:off x="1802160" y="1862640"/>
                <a:ext cx="91440" cy="69480"/>
              </a:xfrm>
              <a:prstGeom prst="rect">
                <a:avLst/>
              </a:prstGeom>
              <a:solidFill>
                <a:srgbClr val="ff3300"/>
              </a:solidFill>
              <a:ln w="9360">
                <a:solidFill>
                  <a:srgbClr val="ff33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2680" bIns="226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" name=""/>
            <p:cNvGrpSpPr/>
            <p:nvPr/>
          </p:nvGrpSpPr>
          <p:grpSpPr>
            <a:xfrm>
              <a:off x="1697040" y="2036520"/>
              <a:ext cx="314640" cy="69480"/>
              <a:chOff x="1697040" y="2036520"/>
              <a:chExt cx="314640" cy="69480"/>
            </a:xfrm>
          </p:grpSpPr>
          <p:sp>
            <p:nvSpPr>
              <p:cNvPr id="57" name=""/>
              <p:cNvSpPr/>
              <p:nvPr/>
            </p:nvSpPr>
            <p:spPr>
              <a:xfrm flipH="1">
                <a:off x="1697040" y="2080080"/>
                <a:ext cx="314640" cy="0"/>
              </a:xfrm>
              <a:prstGeom prst="line">
                <a:avLst/>
              </a:prstGeom>
              <a:ln w="1908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V="1" rot="10800000">
                <a:off x="1806120" y="2036160"/>
                <a:ext cx="105120" cy="69480"/>
              </a:xfrm>
              <a:prstGeom prst="triangle">
                <a:avLst>
                  <a:gd name="adj" fmla="val 50000"/>
                </a:avLst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23760" bIns="-23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" name=""/>
            <p:cNvSpPr/>
            <p:nvPr/>
          </p:nvSpPr>
          <p:spPr>
            <a:xfrm>
              <a:off x="2034360" y="1619280"/>
              <a:ext cx="1535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3.90.640.10 (Sfam cluster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041200" y="1788840"/>
              <a:ext cx="1407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3.50.7.10 (Sfam cluster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034000" y="1962000"/>
              <a:ext cx="14029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3.50.7.10 (S35 clusters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" name=""/>
          <p:cNvSpPr/>
          <p:nvPr/>
        </p:nvSpPr>
        <p:spPr>
          <a:xfrm>
            <a:off x="2885040" y="6310440"/>
            <a:ext cx="104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Bit distan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0800000">
            <a:off x="758880" y="4390920"/>
            <a:ext cx="362880" cy="147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Euclidean distan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15T18:12:47Z</dcterms:created>
  <dc:creator>ucbcja0</dc:creator>
  <dc:description/>
  <dc:language>en-US</dc:language>
  <cp:lastModifiedBy>.</cp:lastModifiedBy>
  <dcterms:modified xsi:type="dcterms:W3CDTF">2007-09-22T13:41:29Z</dcterms:modified>
  <cp:revision>12</cp:revision>
  <dc:subject/>
  <dc:title>Slide 1</dc:title>
</cp:coreProperties>
</file>